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66" r:id="rId2"/>
    <p:sldId id="263" r:id="rId3"/>
    <p:sldId id="265" r:id="rId4"/>
    <p:sldId id="264" r:id="rId5"/>
    <p:sldId id="267" r:id="rId6"/>
  </p:sldIdLst>
  <p:sldSz cx="9906000" cy="6858000" type="A4"/>
  <p:notesSz cx="6805613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15" autoAdjust="0"/>
    <p:restoredTop sz="85808" autoAdjust="0"/>
  </p:normalViewPr>
  <p:slideViewPr>
    <p:cSldViewPr snapToGrid="0">
      <p:cViewPr>
        <p:scale>
          <a:sx n="100" d="100"/>
          <a:sy n="100" d="100"/>
        </p:scale>
        <p:origin x="1422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82800" cy="82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2B6B23-710D-498A-9B78-1318831FE3EE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1243013"/>
            <a:ext cx="4843463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562" y="4783307"/>
            <a:ext cx="544449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099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4939" y="9440647"/>
            <a:ext cx="2949099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FD37BB-15D7-41CD-9538-57813B7B61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3703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Figure S1 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RP-UPLC chromatograms of the </a:t>
            </a:r>
            <a:r>
              <a:rPr lang="en-US" altLang="ko-KR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glutenin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fraction in Chinese Spring using (a) ACQUITY Peptide BEH C</a:t>
            </a:r>
            <a:r>
              <a:rPr lang="en-US" altLang="ko-KR" sz="1200" baseline="-250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18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column and (b) ACQUITY Protein BEH C</a:t>
            </a:r>
            <a:r>
              <a:rPr lang="en-US" altLang="ko-KR" sz="1200" baseline="-250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4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column</a:t>
            </a:r>
            <a:r>
              <a:rPr lang="en-US" altLang="ko-KR" sz="1200" baseline="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eluted with the same linear ACN gradient of 23-41% for 30min.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ko-KR" altLang="en-US" dirty="0" smtClean="0">
              <a:latin typeface="Palatino Linotype" panose="02040502050505030304" pitchFamily="18" charset="0"/>
            </a:endParaRP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FD37BB-15D7-41CD-9538-57813B7B618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69746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verlap</a:t>
            </a:r>
            <a:r>
              <a:rPr lang="en-US" altLang="ko-KR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of HMW-GS chromatograms run with 10 times using the optimized RP-UPLC method from the Chinese Spring.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FD37BB-15D7-41CD-9538-57813B7B618D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09000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ko-KR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SDS-PAGE</a:t>
            </a:r>
            <a:r>
              <a:rPr lang="en-US" altLang="ko-KR" sz="1200" b="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nalysis of HMW-GS in </a:t>
            </a:r>
            <a:r>
              <a:rPr lang="en-US" altLang="ko-KR" sz="1200" b="0" baseline="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enlea</a:t>
            </a:r>
            <a:r>
              <a:rPr lang="en-US" altLang="ko-KR" sz="1200" b="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, Cheyenne, and Hanno. Two groups of HMW-GS which are indistinguishable by RP-UPLC due to overlap retention time are underlined in blue (1Bx7/1Bx7</a:t>
            </a:r>
            <a:r>
              <a:rPr lang="en-US" altLang="ko-KR" sz="1200" b="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ko-KR" sz="1200" b="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nd 1Bx14 ) and red (1By8*, 1By9 and 1By15).</a:t>
            </a:r>
            <a:endParaRPr lang="ko-KR" alt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FD37BB-15D7-41CD-9538-57813B7B618D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38861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CR amplification to determine the 1Bx7</a:t>
            </a:r>
            <a:r>
              <a:rPr lang="en-US" altLang="ko-K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E </a:t>
            </a:r>
            <a:r>
              <a:rPr lang="en-US" altLang="ko-KR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genotyp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Left and Right refer to the junction of the LTR retrotransposon associated with 1Bx7</a:t>
            </a:r>
            <a:r>
              <a:rPr lang="en-US" altLang="ko-K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[16]. The left and right junction of the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troelement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the duplicated region generated 447-bp and 844-bp amplicons respectively in 1Bx7</a:t>
            </a:r>
            <a:r>
              <a:rPr lang="en-US" altLang="ko-K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heyenne (CH) and Chinese Spring (CS) were used as negative controls for 1Bx7</a:t>
            </a:r>
            <a:r>
              <a:rPr lang="en-US" altLang="ko-K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enlea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GL) and IT166460 (IT) were used as positive controls for 1Bx7</a:t>
            </a:r>
            <a:r>
              <a:rPr lang="en-US" altLang="ko-K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[41]. Marker (M) is 100bp Plus DNA Ladder.</a:t>
            </a:r>
            <a:endParaRPr lang="ko-KR" altLang="en-US" sz="1200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dirty="0" smtClean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FD37BB-15D7-41CD-9538-57813B7B618D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39971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Figure S5. 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RP-UPLC chromatograms of the HMW-GS in (a) Insignia (b) </a:t>
            </a:r>
            <a:r>
              <a:rPr lang="en-US" altLang="ko-KR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Manital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and (c) mixture of Insignia and </a:t>
            </a:r>
            <a:r>
              <a:rPr lang="en-US" altLang="ko-KR" sz="12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Manital</a:t>
            </a:r>
            <a:r>
              <a:rPr lang="en-US" altLang="ko-KR" sz="1200" baseline="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  <a:r>
              <a:rPr lang="en-US" altLang="ko-KR" sz="12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ko-KR" altLang="en-US" dirty="0" smtClean="0">
              <a:latin typeface="Palatino Linotype" panose="02040502050505030304" pitchFamily="18" charset="0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D273EC-493F-4B02-89F8-D0FE5F800B86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77232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229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0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3309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8417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4929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6240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5227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7833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9363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9849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527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45F7F-FB9A-4A66-8CF8-E4B0CD1F1347}" type="datetimeFigureOut">
              <a:rPr lang="ko-KR" altLang="en-US" smtClean="0"/>
              <a:t>2021-09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B3CFA-2E71-45F8-BC12-F0432775C77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817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7430"/>
            <a:ext cx="9781010" cy="6840570"/>
          </a:xfrm>
          <a:prstGeom prst="rect">
            <a:avLst/>
          </a:prstGeom>
        </p:spPr>
      </p:pic>
      <p:sp>
        <p:nvSpPr>
          <p:cNvPr id="41" name="직사각형 40"/>
          <p:cNvSpPr/>
          <p:nvPr/>
        </p:nvSpPr>
        <p:spPr>
          <a:xfrm>
            <a:off x="1018330" y="136758"/>
            <a:ext cx="54694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991078" y="3175470"/>
            <a:ext cx="56137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2616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6116" y="444749"/>
            <a:ext cx="6553768" cy="5968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5843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5658" y="646410"/>
            <a:ext cx="5450114" cy="5565180"/>
          </a:xfrm>
          <a:prstGeom prst="rect">
            <a:avLst/>
          </a:prstGeom>
        </p:spPr>
      </p:pic>
      <p:cxnSp>
        <p:nvCxnSpPr>
          <p:cNvPr id="11" name="직선 연결선 10"/>
          <p:cNvCxnSpPr/>
          <p:nvPr/>
        </p:nvCxnSpPr>
        <p:spPr>
          <a:xfrm>
            <a:off x="2889093" y="4093019"/>
            <a:ext cx="1260000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4468515" y="4094589"/>
            <a:ext cx="1260000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/>
          <p:cNvCxnSpPr/>
          <p:nvPr/>
        </p:nvCxnSpPr>
        <p:spPr>
          <a:xfrm>
            <a:off x="6066986" y="4246988"/>
            <a:ext cx="1260000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870835" y="4859352"/>
            <a:ext cx="126000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>
            <a:off x="4458889" y="5011354"/>
            <a:ext cx="126000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6066986" y="4693206"/>
            <a:ext cx="126000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02802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92" y="1593273"/>
            <a:ext cx="9839608" cy="3696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78372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그룹 92">
            <a:extLst>
              <a:ext uri="{FF2B5EF4-FFF2-40B4-BE49-F238E27FC236}">
                <a16:creationId xmlns:a16="http://schemas.microsoft.com/office/drawing/2014/main" id="{469BE9A7-CDA2-48D9-9A1A-B625FD71ABE3}"/>
              </a:ext>
            </a:extLst>
          </p:cNvPr>
          <p:cNvGrpSpPr/>
          <p:nvPr/>
        </p:nvGrpSpPr>
        <p:grpSpPr>
          <a:xfrm>
            <a:off x="519461" y="822810"/>
            <a:ext cx="6097327" cy="5243070"/>
            <a:chOff x="1879822" y="1474377"/>
            <a:chExt cx="6265676" cy="5211432"/>
          </a:xfrm>
        </p:grpSpPr>
        <p:pic>
          <p:nvPicPr>
            <p:cNvPr id="86" name="그림 85">
              <a:extLst>
                <a:ext uri="{FF2B5EF4-FFF2-40B4-BE49-F238E27FC236}">
                  <a16:creationId xmlns:a16="http://schemas.microsoft.com/office/drawing/2014/main" id="{F339A4EE-3968-40FB-9E8A-C7C5248143C1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9" t="3751" r="2151" b="11159"/>
            <a:stretch/>
          </p:blipFill>
          <p:spPr>
            <a:xfrm>
              <a:off x="3719606" y="4957154"/>
              <a:ext cx="4288770" cy="1066162"/>
            </a:xfrm>
            <a:prstGeom prst="rect">
              <a:avLst/>
            </a:prstGeom>
          </p:spPr>
        </p:pic>
        <p:pic>
          <p:nvPicPr>
            <p:cNvPr id="83" name="그림 82">
              <a:extLst>
                <a:ext uri="{FF2B5EF4-FFF2-40B4-BE49-F238E27FC236}">
                  <a16:creationId xmlns:a16="http://schemas.microsoft.com/office/drawing/2014/main" id="{1CD09357-498F-475D-8C31-8E4B96E3D302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9" t="5213" r="3014" b="10724"/>
            <a:stretch/>
          </p:blipFill>
          <p:spPr>
            <a:xfrm>
              <a:off x="3702818" y="3480236"/>
              <a:ext cx="4302295" cy="1080000"/>
            </a:xfrm>
            <a:prstGeom prst="rect">
              <a:avLst/>
            </a:prstGeom>
          </p:spPr>
        </p:pic>
        <p:pic>
          <p:nvPicPr>
            <p:cNvPr id="81" name="그림 80">
              <a:extLst>
                <a:ext uri="{FF2B5EF4-FFF2-40B4-BE49-F238E27FC236}">
                  <a16:creationId xmlns:a16="http://schemas.microsoft.com/office/drawing/2014/main" id="{C7525B42-EA14-4D1B-B898-B44BE516886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7" t="2907" r="2857" b="12236"/>
            <a:stretch/>
          </p:blipFill>
          <p:spPr>
            <a:xfrm>
              <a:off x="3707150" y="2052599"/>
              <a:ext cx="4309200" cy="1063124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46D0BBC-8E4E-4807-9F0B-319355A14C04}"/>
                </a:ext>
              </a:extLst>
            </p:cNvPr>
            <p:cNvSpPr txBox="1"/>
            <p:nvPr/>
          </p:nvSpPr>
          <p:spPr>
            <a:xfrm>
              <a:off x="6932959" y="5299791"/>
              <a:ext cx="420381" cy="365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+2*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  <a:p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54041009-9832-4E3E-93DE-3E06A4162FE7}"/>
                </a:ext>
              </a:extLst>
            </p:cNvPr>
            <p:cNvCxnSpPr/>
            <p:nvPr/>
          </p:nvCxnSpPr>
          <p:spPr>
            <a:xfrm>
              <a:off x="5861355" y="6030667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E25D553A-3032-4E62-89D6-B5592150FC97}"/>
                </a:ext>
              </a:extLst>
            </p:cNvPr>
            <p:cNvCxnSpPr/>
            <p:nvPr/>
          </p:nvCxnSpPr>
          <p:spPr>
            <a:xfrm>
              <a:off x="5861355" y="6030667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950127E-D365-4934-AF02-FA284666438A}"/>
                </a:ext>
              </a:extLst>
            </p:cNvPr>
            <p:cNvSpPr txBox="1"/>
            <p:nvPr/>
          </p:nvSpPr>
          <p:spPr>
            <a:xfrm>
              <a:off x="3565601" y="6092985"/>
              <a:ext cx="265539" cy="265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</a:t>
              </a:r>
              <a:endParaRPr lang="ko-KR" altLang="en-US" sz="1138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29EE226-B3B3-4FDB-88ED-61584EAD7E37}"/>
                </a:ext>
              </a:extLst>
            </p:cNvPr>
            <p:cNvSpPr txBox="1"/>
            <p:nvPr/>
          </p:nvSpPr>
          <p:spPr>
            <a:xfrm>
              <a:off x="7879959" y="6092985"/>
              <a:ext cx="265539" cy="265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6</a:t>
              </a:r>
              <a:endParaRPr lang="ko-KR" altLang="en-US" sz="1138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343E2AF2-38CE-442E-91D9-922FD6C8C81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67105" y="1933787"/>
              <a:ext cx="0" cy="410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7D9DBDF7-45DE-4C07-B93F-11C9DC5E5A4D}"/>
                </a:ext>
              </a:extLst>
            </p:cNvPr>
            <p:cNvCxnSpPr/>
            <p:nvPr/>
          </p:nvCxnSpPr>
          <p:spPr>
            <a:xfrm rot="16200000">
              <a:off x="2736997" y="3427517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FF71E600-F29E-4368-BB66-BE2C7502C1BE}"/>
                </a:ext>
              </a:extLst>
            </p:cNvPr>
            <p:cNvCxnSpPr/>
            <p:nvPr/>
          </p:nvCxnSpPr>
          <p:spPr>
            <a:xfrm rot="16200000">
              <a:off x="2736997" y="4514110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82C77F3-2A86-42C5-A009-C4D33C73E05F}"/>
                </a:ext>
              </a:extLst>
            </p:cNvPr>
            <p:cNvSpPr txBox="1"/>
            <p:nvPr/>
          </p:nvSpPr>
          <p:spPr>
            <a:xfrm flipV="1">
              <a:off x="1879822" y="3191145"/>
              <a:ext cx="395343" cy="158928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Intensity [</a:t>
              </a:r>
              <a:r>
                <a:rPr lang="en-US" altLang="ko-KR" sz="1300" b="1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a.u</a:t>
              </a:r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.]</a:t>
              </a:r>
              <a:endParaRPr lang="ko-KR" altLang="en-US" sz="13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4F25223-9F55-4BFE-B81A-5A94A348FD0C}"/>
                </a:ext>
              </a:extLst>
            </p:cNvPr>
            <p:cNvSpPr txBox="1"/>
            <p:nvPr/>
          </p:nvSpPr>
          <p:spPr>
            <a:xfrm rot="5400000" flipV="1">
              <a:off x="2345021" y="3301841"/>
              <a:ext cx="357607" cy="32220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05EC957-13AB-408B-A044-AC1F22DDAA82}"/>
                </a:ext>
              </a:extLst>
            </p:cNvPr>
            <p:cNvSpPr txBox="1"/>
            <p:nvPr/>
          </p:nvSpPr>
          <p:spPr>
            <a:xfrm rot="5400000" flipV="1">
              <a:off x="2345019" y="4789141"/>
              <a:ext cx="357607" cy="32220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73E0C68-6182-46F1-A079-6EE6BEF410F7}"/>
                </a:ext>
              </a:extLst>
            </p:cNvPr>
            <p:cNvSpPr txBox="1"/>
            <p:nvPr/>
          </p:nvSpPr>
          <p:spPr>
            <a:xfrm rot="5400000" flipV="1">
              <a:off x="2400963" y="5952019"/>
              <a:ext cx="357607" cy="1706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38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A3869812-A5A5-4046-98B9-098F43AC07DA}"/>
                </a:ext>
              </a:extLst>
            </p:cNvPr>
            <p:cNvCxnSpPr/>
            <p:nvPr/>
          </p:nvCxnSpPr>
          <p:spPr>
            <a:xfrm rot="16200000">
              <a:off x="2736995" y="4915375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EB36F0C-E821-44E7-9A5D-0C5F79399533}"/>
                </a:ext>
              </a:extLst>
            </p:cNvPr>
            <p:cNvSpPr txBox="1"/>
            <p:nvPr/>
          </p:nvSpPr>
          <p:spPr>
            <a:xfrm rot="5400000" flipV="1">
              <a:off x="2434789" y="4464719"/>
              <a:ext cx="357607" cy="1706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8E30B066-2D84-40C9-A8F2-AB7A74CA36C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70816" y="6030668"/>
              <a:ext cx="5343342" cy="668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16F24E60-AA5C-46AE-B3AF-A3D21C7AE8E9}"/>
                </a:ext>
              </a:extLst>
            </p:cNvPr>
            <p:cNvCxnSpPr/>
            <p:nvPr/>
          </p:nvCxnSpPr>
          <p:spPr>
            <a:xfrm rot="16200000">
              <a:off x="3670243" y="5999818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9B046C2-1C43-40F2-8EAA-EAE36D2F6C72}"/>
                </a:ext>
              </a:extLst>
            </p:cNvPr>
            <p:cNvSpPr txBox="1"/>
            <p:nvPr/>
          </p:nvSpPr>
          <p:spPr>
            <a:xfrm>
              <a:off x="4856617" y="6395185"/>
              <a:ext cx="848669" cy="290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Minutes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D380A8B-B553-4531-B38A-75ACFC0D18B0}"/>
                </a:ext>
              </a:extLst>
            </p:cNvPr>
            <p:cNvSpPr txBox="1"/>
            <p:nvPr/>
          </p:nvSpPr>
          <p:spPr>
            <a:xfrm>
              <a:off x="4521026" y="3480237"/>
              <a:ext cx="308367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2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0C4863F-667A-48FC-BC30-66C839CB004E}"/>
                </a:ext>
              </a:extLst>
            </p:cNvPr>
            <p:cNvSpPr txBox="1"/>
            <p:nvPr/>
          </p:nvSpPr>
          <p:spPr>
            <a:xfrm>
              <a:off x="6950091" y="3969581"/>
              <a:ext cx="301778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*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BF8097B-3981-4FC3-93F2-A1EC4EA8A96C}"/>
                </a:ext>
              </a:extLst>
            </p:cNvPr>
            <p:cNvSpPr txBox="1"/>
            <p:nvPr/>
          </p:nvSpPr>
          <p:spPr>
            <a:xfrm>
              <a:off x="5337278" y="3608771"/>
              <a:ext cx="308367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8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C84797A-554C-4622-BE4D-D08E668484B9}"/>
                </a:ext>
              </a:extLst>
            </p:cNvPr>
            <p:cNvSpPr txBox="1"/>
            <p:nvPr/>
          </p:nvSpPr>
          <p:spPr>
            <a:xfrm>
              <a:off x="6111558" y="3210865"/>
              <a:ext cx="249066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0ACB1FE-9669-4650-9C9B-B6604B606748}"/>
                </a:ext>
              </a:extLst>
            </p:cNvPr>
            <p:cNvSpPr txBox="1"/>
            <p:nvPr/>
          </p:nvSpPr>
          <p:spPr>
            <a:xfrm>
              <a:off x="2768472" y="3562446"/>
              <a:ext cx="1074345" cy="290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(b) </a:t>
              </a:r>
              <a:r>
                <a:rPr lang="en-US" altLang="ko-KR" sz="1300" b="1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Manital</a:t>
              </a:r>
              <a:endParaRPr lang="ko-KR" altLang="en-US" sz="13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D182139-92E4-42C8-B7C9-829BA7FC4AB9}"/>
                </a:ext>
              </a:extLst>
            </p:cNvPr>
            <p:cNvSpPr txBox="1"/>
            <p:nvPr/>
          </p:nvSpPr>
          <p:spPr>
            <a:xfrm>
              <a:off x="2714779" y="5067811"/>
              <a:ext cx="1938096" cy="290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(c) Insignia &amp; </a:t>
              </a:r>
              <a:r>
                <a:rPr lang="en-US" altLang="ko-KR" sz="1300" b="1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Manital</a:t>
              </a:r>
              <a:endParaRPr lang="en-US" altLang="ko-KR" sz="13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8A297E9-B2EE-44BE-A629-A0F63A5E1CFF}"/>
                </a:ext>
              </a:extLst>
            </p:cNvPr>
            <p:cNvSpPr txBox="1"/>
            <p:nvPr/>
          </p:nvSpPr>
          <p:spPr>
            <a:xfrm>
              <a:off x="6383764" y="4919407"/>
              <a:ext cx="308367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7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F7506BE-7C64-4078-957E-55EEFE1B139C}"/>
                </a:ext>
              </a:extLst>
            </p:cNvPr>
            <p:cNvSpPr txBox="1"/>
            <p:nvPr/>
          </p:nvSpPr>
          <p:spPr>
            <a:xfrm>
              <a:off x="6135970" y="4731482"/>
              <a:ext cx="249066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3268619-1BAB-42B8-B8EE-8280E8BAC23B}"/>
                </a:ext>
              </a:extLst>
            </p:cNvPr>
            <p:cNvSpPr txBox="1"/>
            <p:nvPr/>
          </p:nvSpPr>
          <p:spPr>
            <a:xfrm>
              <a:off x="5394338" y="5233856"/>
              <a:ext cx="308367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8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419AE96-F95A-4EB8-A4E6-33C50F8F708B}"/>
                </a:ext>
              </a:extLst>
            </p:cNvPr>
            <p:cNvSpPr txBox="1"/>
            <p:nvPr/>
          </p:nvSpPr>
          <p:spPr>
            <a:xfrm>
              <a:off x="2738735" y="2048614"/>
              <a:ext cx="1082582" cy="290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(a) Insigni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00971AE-7726-43D6-A4DD-5B4195203855}"/>
                </a:ext>
              </a:extLst>
            </p:cNvPr>
            <p:cNvSpPr txBox="1"/>
            <p:nvPr/>
          </p:nvSpPr>
          <p:spPr>
            <a:xfrm>
              <a:off x="4542469" y="2004646"/>
              <a:ext cx="308367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0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521C1A8-6788-44CB-81EA-84F25878C21C}"/>
                </a:ext>
              </a:extLst>
            </p:cNvPr>
            <p:cNvSpPr txBox="1"/>
            <p:nvPr/>
          </p:nvSpPr>
          <p:spPr>
            <a:xfrm>
              <a:off x="6106085" y="1768469"/>
              <a:ext cx="249066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CF9DADA-4FC1-4F8C-9B7F-FE3C66675FAC}"/>
                </a:ext>
              </a:extLst>
            </p:cNvPr>
            <p:cNvSpPr txBox="1"/>
            <p:nvPr/>
          </p:nvSpPr>
          <p:spPr>
            <a:xfrm>
              <a:off x="5274154" y="2251920"/>
              <a:ext cx="374258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y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8E31E7D-0A8B-4439-A1AF-B35C1E6B45C1}"/>
                </a:ext>
              </a:extLst>
            </p:cNvPr>
            <p:cNvSpPr txBox="1"/>
            <p:nvPr/>
          </p:nvSpPr>
          <p:spPr>
            <a:xfrm>
              <a:off x="4634016" y="6092985"/>
              <a:ext cx="275422" cy="290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3</a:t>
              </a:r>
              <a:endParaRPr lang="ko-KR" altLang="en-US" sz="13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F6B46F7-838E-4ECD-8348-99CA9CF5D92C}"/>
                </a:ext>
              </a:extLst>
            </p:cNvPr>
            <p:cNvSpPr txBox="1"/>
            <p:nvPr/>
          </p:nvSpPr>
          <p:spPr>
            <a:xfrm>
              <a:off x="5715997" y="6092985"/>
              <a:ext cx="275422" cy="290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4</a:t>
              </a:r>
              <a:endParaRPr lang="ko-KR" altLang="en-US" sz="13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42AA009-4CD7-4215-8E4F-D8AE2CE79628}"/>
                </a:ext>
              </a:extLst>
            </p:cNvPr>
            <p:cNvSpPr txBox="1"/>
            <p:nvPr/>
          </p:nvSpPr>
          <p:spPr>
            <a:xfrm>
              <a:off x="6797978" y="6092985"/>
              <a:ext cx="275422" cy="2906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3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13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직선 연결선 42">
              <a:extLst>
                <a:ext uri="{FF2B5EF4-FFF2-40B4-BE49-F238E27FC236}">
                  <a16:creationId xmlns:a16="http://schemas.microsoft.com/office/drawing/2014/main" id="{0B7F5A2B-F1B0-4AC7-ABB4-6961EA87FCE8}"/>
                </a:ext>
              </a:extLst>
            </p:cNvPr>
            <p:cNvCxnSpPr/>
            <p:nvPr/>
          </p:nvCxnSpPr>
          <p:spPr>
            <a:xfrm>
              <a:off x="4783445" y="6037347"/>
              <a:ext cx="0" cy="639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BED7A233-7D8D-4F7C-940A-D54F5403B60E}"/>
                </a:ext>
              </a:extLst>
            </p:cNvPr>
            <p:cNvCxnSpPr/>
            <p:nvPr/>
          </p:nvCxnSpPr>
          <p:spPr>
            <a:xfrm>
              <a:off x="5861355" y="6030667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5DB5E88A-349C-45F1-BBA0-DACE74C25DB4}"/>
                </a:ext>
              </a:extLst>
            </p:cNvPr>
            <p:cNvCxnSpPr/>
            <p:nvPr/>
          </p:nvCxnSpPr>
          <p:spPr>
            <a:xfrm>
              <a:off x="6939265" y="6030667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CDEED2D2-40F3-44C2-AAE6-E48166AC5300}"/>
                </a:ext>
              </a:extLst>
            </p:cNvPr>
            <p:cNvCxnSpPr/>
            <p:nvPr/>
          </p:nvCxnSpPr>
          <p:spPr>
            <a:xfrm>
              <a:off x="8017176" y="6035110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6E80C6FF-CA98-4793-BA7A-DF9D1AC50256}"/>
                </a:ext>
              </a:extLst>
            </p:cNvPr>
            <p:cNvCxnSpPr/>
            <p:nvPr/>
          </p:nvCxnSpPr>
          <p:spPr>
            <a:xfrm>
              <a:off x="3702818" y="6037347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FAB1ABDC-1204-4265-A782-1AE9B5927BE3}"/>
                </a:ext>
              </a:extLst>
            </p:cNvPr>
            <p:cNvCxnSpPr/>
            <p:nvPr/>
          </p:nvCxnSpPr>
          <p:spPr>
            <a:xfrm rot="16200000">
              <a:off x="2742911" y="1911606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03B71661-4C1D-4BD9-AA00-DE494AC61EFB}"/>
                </a:ext>
              </a:extLst>
            </p:cNvPr>
            <p:cNvCxnSpPr/>
            <p:nvPr/>
          </p:nvCxnSpPr>
          <p:spPr>
            <a:xfrm rot="16200000">
              <a:off x="2742911" y="2998199"/>
              <a:ext cx="0" cy="705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6B711748-7153-4082-ADFC-61D1F80C85FE}"/>
                </a:ext>
              </a:extLst>
            </p:cNvPr>
            <p:cNvSpPr txBox="1"/>
            <p:nvPr/>
          </p:nvSpPr>
          <p:spPr>
            <a:xfrm rot="5400000" flipV="1">
              <a:off x="2350935" y="1785930"/>
              <a:ext cx="357607" cy="32220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E79A0F6-4658-4DC7-8051-00D40CF513BA}"/>
                </a:ext>
              </a:extLst>
            </p:cNvPr>
            <p:cNvSpPr txBox="1"/>
            <p:nvPr/>
          </p:nvSpPr>
          <p:spPr>
            <a:xfrm rot="5400000" flipV="1">
              <a:off x="2440703" y="2948808"/>
              <a:ext cx="357607" cy="1706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138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2D8C7995-CC07-4861-8298-4205A3C91EED}"/>
                </a:ext>
              </a:extLst>
            </p:cNvPr>
            <p:cNvCxnSpPr/>
            <p:nvPr/>
          </p:nvCxnSpPr>
          <p:spPr>
            <a:xfrm flipV="1">
              <a:off x="5059731" y="1937332"/>
              <a:ext cx="0" cy="410400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A76BA10B-9F4B-493F-8690-2E18027BC195}"/>
                </a:ext>
              </a:extLst>
            </p:cNvPr>
            <p:cNvCxnSpPr/>
            <p:nvPr/>
          </p:nvCxnSpPr>
          <p:spPr>
            <a:xfrm flipV="1">
              <a:off x="5943628" y="1937332"/>
              <a:ext cx="0" cy="410400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C331FC7C-C1F4-43E9-A220-02DC3592A472}"/>
                </a:ext>
              </a:extLst>
            </p:cNvPr>
            <p:cNvCxnSpPr/>
            <p:nvPr/>
          </p:nvCxnSpPr>
          <p:spPr>
            <a:xfrm flipV="1">
              <a:off x="6953755" y="1937332"/>
              <a:ext cx="0" cy="410400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1718A83-3E43-4EDB-96C5-2DE74FD710C6}"/>
                </a:ext>
              </a:extLst>
            </p:cNvPr>
            <p:cNvSpPr txBox="1"/>
            <p:nvPr/>
          </p:nvSpPr>
          <p:spPr>
            <a:xfrm>
              <a:off x="4368861" y="1474377"/>
              <a:ext cx="431913" cy="2409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75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Dy</a:t>
              </a:r>
              <a:endParaRPr lang="ko-KR" altLang="en-US" sz="975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A1386C9-F53A-44DD-B03B-0839C1220ABB}"/>
                </a:ext>
              </a:extLst>
            </p:cNvPr>
            <p:cNvSpPr txBox="1"/>
            <p:nvPr/>
          </p:nvSpPr>
          <p:spPr>
            <a:xfrm>
              <a:off x="5208772" y="1474377"/>
              <a:ext cx="410497" cy="2409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75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By</a:t>
              </a:r>
              <a:endParaRPr lang="ko-KR" altLang="en-US" sz="975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27896EB-0470-4823-B9BE-DFBF326605A2}"/>
                </a:ext>
              </a:extLst>
            </p:cNvPr>
            <p:cNvSpPr txBox="1"/>
            <p:nvPr/>
          </p:nvSpPr>
          <p:spPr>
            <a:xfrm>
              <a:off x="6021431" y="1474377"/>
              <a:ext cx="677354" cy="2409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75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Dx/1Bx</a:t>
              </a:r>
              <a:endParaRPr lang="ko-KR" altLang="en-US" sz="975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30300659-FC21-4E38-AB88-27D1668CDB39}"/>
                </a:ext>
              </a:extLst>
            </p:cNvPr>
            <p:cNvSpPr txBox="1"/>
            <p:nvPr/>
          </p:nvSpPr>
          <p:spPr>
            <a:xfrm>
              <a:off x="7153090" y="1474377"/>
              <a:ext cx="418735" cy="2409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75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Ax</a:t>
              </a:r>
              <a:endParaRPr lang="ko-KR" altLang="en-US" sz="975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6365D44-6476-4566-B5EE-26D9774C25B3}"/>
                </a:ext>
              </a:extLst>
            </p:cNvPr>
            <p:cNvSpPr txBox="1"/>
            <p:nvPr/>
          </p:nvSpPr>
          <p:spPr>
            <a:xfrm>
              <a:off x="6618742" y="2098247"/>
              <a:ext cx="367669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x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D799823-5467-4819-BFC3-E5F3D457DC13}"/>
                </a:ext>
              </a:extLst>
            </p:cNvPr>
            <p:cNvSpPr txBox="1"/>
            <p:nvPr/>
          </p:nvSpPr>
          <p:spPr>
            <a:xfrm>
              <a:off x="6965875" y="2419982"/>
              <a:ext cx="249066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F841800-6A0E-4373-A7FC-A0145DE7A2FC}"/>
                </a:ext>
              </a:extLst>
            </p:cNvPr>
            <p:cNvSpPr txBox="1"/>
            <p:nvPr/>
          </p:nvSpPr>
          <p:spPr>
            <a:xfrm>
              <a:off x="6376522" y="3216389"/>
              <a:ext cx="308367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7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EA40873-DC59-4F7E-AFF9-A3E28D0F6165}"/>
                </a:ext>
              </a:extLst>
            </p:cNvPr>
            <p:cNvSpPr txBox="1"/>
            <p:nvPr/>
          </p:nvSpPr>
          <p:spPr>
            <a:xfrm>
              <a:off x="4425628" y="4834206"/>
              <a:ext cx="701263" cy="2285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0+12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89758AC3-DD91-4D3D-8C11-97EC88A2D8DE}"/>
                </a:ext>
              </a:extLst>
            </p:cNvPr>
            <p:cNvSpPr txBox="1"/>
            <p:nvPr/>
          </p:nvSpPr>
          <p:spPr>
            <a:xfrm>
              <a:off x="5113288" y="5393053"/>
              <a:ext cx="374258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y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41FE14E-4667-4BEE-9ED1-8F4EC1A2A6C9}"/>
                </a:ext>
              </a:extLst>
            </p:cNvPr>
            <p:cNvSpPr txBox="1"/>
            <p:nvPr/>
          </p:nvSpPr>
          <p:spPr>
            <a:xfrm>
              <a:off x="6015915" y="4817739"/>
              <a:ext cx="249066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6EE163F7-2978-4280-A733-DF9EA5A4A187}"/>
                </a:ext>
              </a:extLst>
            </p:cNvPr>
            <p:cNvSpPr txBox="1"/>
            <p:nvPr/>
          </p:nvSpPr>
          <p:spPr>
            <a:xfrm>
              <a:off x="6633982" y="5141167"/>
              <a:ext cx="367669" cy="2285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94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x</a:t>
              </a:r>
              <a:endParaRPr lang="ko-KR" altLang="en-US" sz="894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60676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79</TotalTime>
  <Words>298</Words>
  <Application>Microsoft Office PowerPoint</Application>
  <PresentationFormat>A4 용지(210x297mm)</PresentationFormat>
  <Paragraphs>50</Paragraphs>
  <Slides>5</Slides>
  <Notes>5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</dc:creator>
  <cp:lastModifiedBy>user</cp:lastModifiedBy>
  <cp:revision>88</cp:revision>
  <cp:lastPrinted>2021-08-03T00:15:45Z</cp:lastPrinted>
  <dcterms:created xsi:type="dcterms:W3CDTF">2021-04-17T07:28:13Z</dcterms:created>
  <dcterms:modified xsi:type="dcterms:W3CDTF">2021-09-27T08:57:36Z</dcterms:modified>
</cp:coreProperties>
</file>